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5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84" y="3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D8824D-86F5-CAD7-CD24-7CAC1514899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2415999-363D-8E2B-CB41-A8BBF72F64C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EC42CD-5F8D-D240-43FA-79109BF6F0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91D0F-CA2B-4D4D-A9B2-9EA5896C2D13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181056-F986-F50E-77CA-F1DA7210D8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67A2A1-3AA4-66F1-7959-2F0D1484AC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CFA72-358D-4A9B-9CB9-0CCF3581C0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03274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F223A7-2085-9078-A3DC-A9BFA38A52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BD4BDA7-A8B8-DBEC-50A1-DBE3ACA5C43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59DB40-A175-2205-AE1E-8455781EA3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91D0F-CA2B-4D4D-A9B2-9EA5896C2D13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1FBEE2-91B7-FDB4-65BF-A79AE14F53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EE7BBC-9C4B-403C-DD05-57C02D6044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CFA72-358D-4A9B-9CB9-0CCF3581C0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70760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8D172FB-5532-7FE6-10A1-D66ECE31DBA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E3F88C5-CAA2-C110-00C8-807C1A1A7B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9CB695-A864-131F-837F-DB757FE991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91D0F-CA2B-4D4D-A9B2-9EA5896C2D13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E04E16-9D57-C354-FC8B-3A7F0A0D1C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93FD2B-F5F8-F369-8A83-6B368E0BA4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CFA72-358D-4A9B-9CB9-0CCF3581C0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26797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32B469-83E6-66F4-6644-09FA21A8D0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EC39E6D-0E0A-65CD-B3FB-11D89B3F690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499136-4A8B-769C-6530-1838B7B557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91D0F-CA2B-4D4D-A9B2-9EA5896C2D13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CD0CF9-9BC6-E9C7-2C5F-FE081DD7CC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B8A156-0C47-FCA6-BEDF-75B228F9CD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CFA72-358D-4A9B-9CB9-0CCF3581C0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36148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04232C-F07B-4F49-EEEC-7F7F36ADC1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148611B-2C42-101A-622E-5A4043AFFB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8D6C69-B039-E458-49CA-09D55D1A93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91D0F-CA2B-4D4D-A9B2-9EA5896C2D13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E689E5-0482-A4D5-C491-6ABBBBB905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DD4D0B-877E-C008-CD94-E38934AE0C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CFA72-358D-4A9B-9CB9-0CCF3581C0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22796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0C2507-8605-FFC5-4061-BE71674185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B5B3956-232C-7259-7C9E-96A60260C65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1BCC113-6749-F05B-68B7-D90B58DC540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9A01AB-28EF-999B-1642-B36141557B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91D0F-CA2B-4D4D-A9B2-9EA5896C2D13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0A382D6-0CB4-4FC5-C113-1479E2D42D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8AD2FD7-68CC-CCA6-2407-D9ECA45B27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CFA72-358D-4A9B-9CB9-0CCF3581C0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13355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46AD6D-6A20-971C-7096-787F81E400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9F2927D-4494-6CE6-AA06-839BDE2DE7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24A41AC-A088-F903-CA70-AACF2E14980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95EB4A5-0BC4-62B8-2CD8-35A0B864E9C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2C9744F-B540-C8FE-F889-204B023CD5C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F7564BE-926E-3052-C7B3-592590AE46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91D0F-CA2B-4D4D-A9B2-9EA5896C2D13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79A0A32-E2A3-B689-60BA-1D77183D57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E5CEF8C-D7A2-6E87-A570-2453928B46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CFA72-358D-4A9B-9CB9-0CCF3581C0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52210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489514-7BC2-0684-88D9-C12634664F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47C905E-2E29-ED53-A1FD-67A1FA0B9D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91D0F-CA2B-4D4D-A9B2-9EA5896C2D13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A141909-6728-0418-385A-54DC222B7A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D0F2DE1-D207-C3D1-90D0-AFD0E53903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CFA72-358D-4A9B-9CB9-0CCF3581C0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6777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4D0982A-FA37-33CB-E1E9-AA65D1F998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91D0F-CA2B-4D4D-A9B2-9EA5896C2D13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ADD1886-BD6A-6540-20A2-85DE526E10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DBC914E-09EC-B777-442E-1C1FFE9F8D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CFA72-358D-4A9B-9CB9-0CCF3581C0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53462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4A2E54-0689-6247-5976-1AF88BB5E1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8A1203-A7F6-6014-B6A4-768CCE1AFCE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012F8A5-32B5-938E-95B4-5FDE493DED5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86082B4-26B1-AB48-4826-9781679C5B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91D0F-CA2B-4D4D-A9B2-9EA5896C2D13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C381731-AB34-D3A1-682B-2B1FDA0638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8854AE-3A2C-9AEF-7790-B970C9CC4E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CFA72-358D-4A9B-9CB9-0CCF3581C0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30462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4BA906-0B3D-05E6-80F8-16040AC748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B3CE8C1-286D-18F8-4C7B-3AF9B640A4E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3E556A6-594A-91D5-EBA5-C9AEAC4FC39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688B77-74C5-005D-4721-6297A8A656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91D0F-CA2B-4D4D-A9B2-9EA5896C2D13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046FE0-6718-6563-4A0F-0C79CE96EF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DB9FDEC-5B09-527C-5A57-E4C70ABEEC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CFA72-358D-4A9B-9CB9-0CCF3581C0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4600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6DB1B0C-A594-46F2-9529-F89721B19E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80730F8-41DE-A55B-98B6-A44FCC4939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54BBE5-1352-CFB4-98D4-C36585234DD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B91D0F-CA2B-4D4D-A9B2-9EA5896C2D13}" type="datetimeFigureOut">
              <a:rPr lang="en-US" smtClean="0"/>
              <a:t>7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EA4AA3-5C2A-04AD-372F-90643A45A5F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B040DF-0D69-62FA-CA5E-3CE07F93548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ECFA72-358D-4A9B-9CB9-0CCF3581C0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9664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13" Type="http://schemas.openxmlformats.org/officeDocument/2006/relationships/image" Target="../media/image30.png"/><Relationship Id="rId18" Type="http://schemas.openxmlformats.org/officeDocument/2006/relationships/image" Target="../media/image35.png"/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12" Type="http://schemas.openxmlformats.org/officeDocument/2006/relationships/image" Target="../media/image29.png"/><Relationship Id="rId17" Type="http://schemas.openxmlformats.org/officeDocument/2006/relationships/image" Target="../media/image34.png"/><Relationship Id="rId2" Type="http://schemas.openxmlformats.org/officeDocument/2006/relationships/image" Target="../media/image19.png"/><Relationship Id="rId16" Type="http://schemas.openxmlformats.org/officeDocument/2006/relationships/image" Target="../media/image3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png"/><Relationship Id="rId11" Type="http://schemas.openxmlformats.org/officeDocument/2006/relationships/image" Target="../media/image28.png"/><Relationship Id="rId5" Type="http://schemas.openxmlformats.org/officeDocument/2006/relationships/image" Target="../media/image22.png"/><Relationship Id="rId15" Type="http://schemas.openxmlformats.org/officeDocument/2006/relationships/image" Target="../media/image32.png"/><Relationship Id="rId10" Type="http://schemas.openxmlformats.org/officeDocument/2006/relationships/image" Target="../media/image27.png"/><Relationship Id="rId19" Type="http://schemas.openxmlformats.org/officeDocument/2006/relationships/image" Target="../media/image36.png"/><Relationship Id="rId4" Type="http://schemas.openxmlformats.org/officeDocument/2006/relationships/image" Target="../media/image21.png"/><Relationship Id="rId9" Type="http://schemas.openxmlformats.org/officeDocument/2006/relationships/image" Target="../media/image26.png"/><Relationship Id="rId14" Type="http://schemas.openxmlformats.org/officeDocument/2006/relationships/image" Target="../media/image31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png"/><Relationship Id="rId13" Type="http://schemas.openxmlformats.org/officeDocument/2006/relationships/image" Target="../media/image48.png"/><Relationship Id="rId18" Type="http://schemas.openxmlformats.org/officeDocument/2006/relationships/image" Target="../media/image53.png"/><Relationship Id="rId3" Type="http://schemas.openxmlformats.org/officeDocument/2006/relationships/image" Target="../media/image38.png"/><Relationship Id="rId7" Type="http://schemas.openxmlformats.org/officeDocument/2006/relationships/image" Target="../media/image42.png"/><Relationship Id="rId12" Type="http://schemas.openxmlformats.org/officeDocument/2006/relationships/image" Target="../media/image47.png"/><Relationship Id="rId17" Type="http://schemas.openxmlformats.org/officeDocument/2006/relationships/image" Target="../media/image52.png"/><Relationship Id="rId2" Type="http://schemas.openxmlformats.org/officeDocument/2006/relationships/image" Target="../media/image37.png"/><Relationship Id="rId16" Type="http://schemas.openxmlformats.org/officeDocument/2006/relationships/image" Target="../media/image5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1.png"/><Relationship Id="rId11" Type="http://schemas.openxmlformats.org/officeDocument/2006/relationships/image" Target="../media/image46.png"/><Relationship Id="rId5" Type="http://schemas.openxmlformats.org/officeDocument/2006/relationships/image" Target="../media/image40.png"/><Relationship Id="rId15" Type="http://schemas.openxmlformats.org/officeDocument/2006/relationships/image" Target="../media/image50.png"/><Relationship Id="rId10" Type="http://schemas.openxmlformats.org/officeDocument/2006/relationships/image" Target="../media/image45.png"/><Relationship Id="rId19" Type="http://schemas.openxmlformats.org/officeDocument/2006/relationships/image" Target="../media/image54.png"/><Relationship Id="rId4" Type="http://schemas.openxmlformats.org/officeDocument/2006/relationships/image" Target="../media/image39.png"/><Relationship Id="rId9" Type="http://schemas.openxmlformats.org/officeDocument/2006/relationships/image" Target="../media/image44.png"/><Relationship Id="rId14" Type="http://schemas.openxmlformats.org/officeDocument/2006/relationships/image" Target="../media/image49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61.png"/><Relationship Id="rId3" Type="http://schemas.openxmlformats.org/officeDocument/2006/relationships/image" Target="../media/image56.png"/><Relationship Id="rId7" Type="http://schemas.openxmlformats.org/officeDocument/2006/relationships/image" Target="../media/image60.png"/><Relationship Id="rId2" Type="http://schemas.openxmlformats.org/officeDocument/2006/relationships/image" Target="../media/image5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9.png"/><Relationship Id="rId5" Type="http://schemas.openxmlformats.org/officeDocument/2006/relationships/image" Target="../media/image58.png"/><Relationship Id="rId10" Type="http://schemas.openxmlformats.org/officeDocument/2006/relationships/image" Target="../media/image63.png"/><Relationship Id="rId4" Type="http://schemas.openxmlformats.org/officeDocument/2006/relationships/image" Target="../media/image57.png"/><Relationship Id="rId9" Type="http://schemas.openxmlformats.org/officeDocument/2006/relationships/image" Target="../media/image62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70.png"/><Relationship Id="rId13" Type="http://schemas.openxmlformats.org/officeDocument/2006/relationships/image" Target="../media/image75.png"/><Relationship Id="rId18" Type="http://schemas.openxmlformats.org/officeDocument/2006/relationships/image" Target="../media/image80.png"/><Relationship Id="rId3" Type="http://schemas.openxmlformats.org/officeDocument/2006/relationships/image" Target="../media/image65.png"/><Relationship Id="rId7" Type="http://schemas.openxmlformats.org/officeDocument/2006/relationships/image" Target="../media/image69.png"/><Relationship Id="rId12" Type="http://schemas.openxmlformats.org/officeDocument/2006/relationships/image" Target="../media/image74.png"/><Relationship Id="rId17" Type="http://schemas.openxmlformats.org/officeDocument/2006/relationships/image" Target="../media/image79.png"/><Relationship Id="rId2" Type="http://schemas.openxmlformats.org/officeDocument/2006/relationships/image" Target="../media/image64.png"/><Relationship Id="rId16" Type="http://schemas.openxmlformats.org/officeDocument/2006/relationships/image" Target="../media/image7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8.png"/><Relationship Id="rId11" Type="http://schemas.openxmlformats.org/officeDocument/2006/relationships/image" Target="../media/image73.png"/><Relationship Id="rId5" Type="http://schemas.openxmlformats.org/officeDocument/2006/relationships/image" Target="../media/image67.png"/><Relationship Id="rId15" Type="http://schemas.openxmlformats.org/officeDocument/2006/relationships/image" Target="../media/image77.png"/><Relationship Id="rId10" Type="http://schemas.openxmlformats.org/officeDocument/2006/relationships/image" Target="../media/image72.png"/><Relationship Id="rId19" Type="http://schemas.openxmlformats.org/officeDocument/2006/relationships/image" Target="../media/image81.png"/><Relationship Id="rId4" Type="http://schemas.openxmlformats.org/officeDocument/2006/relationships/image" Target="../media/image66.png"/><Relationship Id="rId9" Type="http://schemas.openxmlformats.org/officeDocument/2006/relationships/image" Target="../media/image71.png"/><Relationship Id="rId14" Type="http://schemas.openxmlformats.org/officeDocument/2006/relationships/image" Target="../media/image76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88.png"/><Relationship Id="rId13" Type="http://schemas.openxmlformats.org/officeDocument/2006/relationships/image" Target="../media/image93.png"/><Relationship Id="rId3" Type="http://schemas.openxmlformats.org/officeDocument/2006/relationships/image" Target="../media/image83.png"/><Relationship Id="rId7" Type="http://schemas.openxmlformats.org/officeDocument/2006/relationships/image" Target="../media/image87.png"/><Relationship Id="rId12" Type="http://schemas.openxmlformats.org/officeDocument/2006/relationships/image" Target="../media/image92.png"/><Relationship Id="rId2" Type="http://schemas.openxmlformats.org/officeDocument/2006/relationships/image" Target="../media/image82.png"/><Relationship Id="rId16" Type="http://schemas.openxmlformats.org/officeDocument/2006/relationships/image" Target="../media/image9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6.png"/><Relationship Id="rId11" Type="http://schemas.openxmlformats.org/officeDocument/2006/relationships/image" Target="../media/image91.png"/><Relationship Id="rId5" Type="http://schemas.openxmlformats.org/officeDocument/2006/relationships/image" Target="../media/image85.png"/><Relationship Id="rId15" Type="http://schemas.openxmlformats.org/officeDocument/2006/relationships/image" Target="../media/image95.png"/><Relationship Id="rId10" Type="http://schemas.openxmlformats.org/officeDocument/2006/relationships/image" Target="../media/image90.png"/><Relationship Id="rId4" Type="http://schemas.openxmlformats.org/officeDocument/2006/relationships/image" Target="../media/image84.png"/><Relationship Id="rId9" Type="http://schemas.openxmlformats.org/officeDocument/2006/relationships/image" Target="../media/image89.png"/><Relationship Id="rId14" Type="http://schemas.openxmlformats.org/officeDocument/2006/relationships/image" Target="../media/image9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65A3D29-96BA-64E7-87F6-4F812EA9FBA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18042" y="658727"/>
            <a:ext cx="3444539" cy="89619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11A12B6-2676-D038-4691-C05712E55B2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22473" y="670920"/>
            <a:ext cx="3420152" cy="871804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9AE00D2B-B705-56CB-1C94-7841DE86494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737109" y="670920"/>
            <a:ext cx="3420152" cy="871804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5E9B78CB-D7E5-6766-B8A1-481C96A3279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18041" y="1609408"/>
            <a:ext cx="3444539" cy="713294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7F734D23-694E-6CAA-0AD0-AE46519BDA2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122473" y="1621601"/>
            <a:ext cx="3420152" cy="688908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71C09F25-17A3-54A3-DAC5-0EEB1A8D973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737109" y="1621601"/>
            <a:ext cx="3420152" cy="688908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97D941CA-60CE-582A-E3A8-018BFB16300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518040" y="2399185"/>
            <a:ext cx="3444539" cy="609653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E7950F3A-EDCD-E9FB-8972-F50CCAB39A1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122473" y="2405281"/>
            <a:ext cx="3420152" cy="59746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E1905B95-473E-2EF8-5913-E5D34904E3A4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737109" y="2411378"/>
            <a:ext cx="3420152" cy="585267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44E5EE1E-9890-66DA-294A-FE9ACCE7ACB9}"/>
              </a:ext>
            </a:extLst>
          </p:cNvPr>
          <p:cNvSpPr txBox="1"/>
          <p:nvPr/>
        </p:nvSpPr>
        <p:spPr>
          <a:xfrm>
            <a:off x="5610931" y="0"/>
            <a:ext cx="970137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200" dirty="0">
                <a:latin typeface="Arial" panose="020B0604020202020204" pitchFamily="34" charset="0"/>
                <a:cs typeface="Arial" panose="020B0604020202020204" pitchFamily="34" charset="0"/>
              </a:rPr>
              <a:t>Fig 2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5959C1A-9C5E-84FF-7BDB-B28B802C96EF}"/>
              </a:ext>
            </a:extLst>
          </p:cNvPr>
          <p:cNvSpPr txBox="1"/>
          <p:nvPr/>
        </p:nvSpPr>
        <p:spPr>
          <a:xfrm>
            <a:off x="2141481" y="352880"/>
            <a:ext cx="209704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hemoluminescenc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C27B6DE-C6FB-F39F-1101-AF0540AD5A59}"/>
              </a:ext>
            </a:extLst>
          </p:cNvPr>
          <p:cNvSpPr txBox="1"/>
          <p:nvPr/>
        </p:nvSpPr>
        <p:spPr>
          <a:xfrm>
            <a:off x="6421219" y="347068"/>
            <a:ext cx="8226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DEA9B15-7276-6DD3-44B6-FB696C59E857}"/>
              </a:ext>
            </a:extLst>
          </p:cNvPr>
          <p:cNvSpPr txBox="1"/>
          <p:nvPr/>
        </p:nvSpPr>
        <p:spPr>
          <a:xfrm>
            <a:off x="10007001" y="347067"/>
            <a:ext cx="8803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Merged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8DF36C0-12C6-EA3C-CE5D-DC3A141D6D98}"/>
              </a:ext>
            </a:extLst>
          </p:cNvPr>
          <p:cNvSpPr txBox="1"/>
          <p:nvPr/>
        </p:nvSpPr>
        <p:spPr>
          <a:xfrm>
            <a:off x="422870" y="937545"/>
            <a:ext cx="10951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H3K9me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0E73604-4599-066F-DA61-30938AD61D84}"/>
              </a:ext>
            </a:extLst>
          </p:cNvPr>
          <p:cNvSpPr txBox="1"/>
          <p:nvPr/>
        </p:nvSpPr>
        <p:spPr>
          <a:xfrm>
            <a:off x="311477" y="1796778"/>
            <a:ext cx="12089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H3K27me3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B06F434-E255-B0D9-225C-A67E888DA01A}"/>
              </a:ext>
            </a:extLst>
          </p:cNvPr>
          <p:cNvSpPr txBox="1"/>
          <p:nvPr/>
        </p:nvSpPr>
        <p:spPr>
          <a:xfrm>
            <a:off x="543924" y="2534734"/>
            <a:ext cx="9361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Total H3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2123BC6-C810-023F-8DC3-E0E942D8A1E6}"/>
              </a:ext>
            </a:extLst>
          </p:cNvPr>
          <p:cNvSpPr txBox="1"/>
          <p:nvPr/>
        </p:nvSpPr>
        <p:spPr>
          <a:xfrm rot="16200000">
            <a:off x="-483265" y="1703897"/>
            <a:ext cx="1258652" cy="4924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600" b="1" dirty="0">
                <a:latin typeface="Arial" panose="020B0604020202020204" pitchFamily="34" charset="0"/>
                <a:cs typeface="Arial" panose="020B0604020202020204" pitchFamily="34" charset="0"/>
              </a:rPr>
              <a:t>Femur</a:t>
            </a:r>
            <a:endParaRPr lang="en-US" sz="2600" b="1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6AE7312-A94C-A626-8119-64A5E6A9C9A7}"/>
              </a:ext>
            </a:extLst>
          </p:cNvPr>
          <p:cNvSpPr txBox="1"/>
          <p:nvPr/>
        </p:nvSpPr>
        <p:spPr>
          <a:xfrm rot="16200000">
            <a:off x="-433849" y="4624913"/>
            <a:ext cx="1159820" cy="4924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600" b="1" dirty="0">
                <a:latin typeface="Arial" panose="020B0604020202020204" pitchFamily="34" charset="0"/>
                <a:cs typeface="Arial" panose="020B0604020202020204" pitchFamily="34" charset="0"/>
              </a:rPr>
              <a:t>Lung</a:t>
            </a:r>
            <a:endParaRPr lang="en-US" sz="2600" b="1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6F6FD2F-6800-C7BB-70C7-083F2732B7C3}"/>
              </a:ext>
            </a:extLst>
          </p:cNvPr>
          <p:cNvSpPr txBox="1"/>
          <p:nvPr/>
        </p:nvSpPr>
        <p:spPr>
          <a:xfrm>
            <a:off x="430108" y="3676128"/>
            <a:ext cx="10951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H3K9me3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049093C-F753-D32D-A1E1-58A573BE4F31}"/>
              </a:ext>
            </a:extLst>
          </p:cNvPr>
          <p:cNvSpPr txBox="1"/>
          <p:nvPr/>
        </p:nvSpPr>
        <p:spPr>
          <a:xfrm>
            <a:off x="365867" y="4702118"/>
            <a:ext cx="12089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H3K27me3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B805F8E-84CC-E70D-A74E-8D56013D1224}"/>
              </a:ext>
            </a:extLst>
          </p:cNvPr>
          <p:cNvSpPr txBox="1"/>
          <p:nvPr/>
        </p:nvSpPr>
        <p:spPr>
          <a:xfrm>
            <a:off x="394079" y="5791238"/>
            <a:ext cx="9361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Total H3</a:t>
            </a: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AD6AEAB4-A068-CAA2-CBF3-C27598601663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685427" y="3412552"/>
            <a:ext cx="2926334" cy="865707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B0FAF266-EF55-DC15-B4FD-EC667F2A2FA1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384624" y="3394262"/>
            <a:ext cx="2895851" cy="902286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939376F7-2AEC-6358-DC34-007682D5AD42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8999260" y="3424745"/>
            <a:ext cx="2895851" cy="841321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CF706C34-85D3-2FFA-3DAD-61059B45DA23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593979" y="4368432"/>
            <a:ext cx="3109229" cy="1005927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86AE7393-A4FE-401F-555A-F44FD8EDE083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8907812" y="4374528"/>
            <a:ext cx="3078747" cy="993734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BE123140-2E90-0884-0563-D50C62E64561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459854" y="5478890"/>
            <a:ext cx="3377477" cy="963251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D4AD6BF2-44AC-4F3D-260A-BEBC5BD5EDC5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5152956" y="5491083"/>
            <a:ext cx="3359187" cy="938865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B86B63A0-07C2-F060-DB8E-431A9532D97A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8767592" y="5491083"/>
            <a:ext cx="3359187" cy="938865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5E16417D-D68D-5DF1-9FF1-3D7CC91D62DF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5293176" y="4374528"/>
            <a:ext cx="3078747" cy="993734"/>
          </a:xfrm>
          <a:prstGeom prst="rect">
            <a:avLst/>
          </a:prstGeom>
        </p:spPr>
      </p:pic>
      <p:grpSp>
        <p:nvGrpSpPr>
          <p:cNvPr id="41" name="Group 40">
            <a:extLst>
              <a:ext uri="{FF2B5EF4-FFF2-40B4-BE49-F238E27FC236}">
                <a16:creationId xmlns:a16="http://schemas.microsoft.com/office/drawing/2014/main" id="{AEF6B82B-A6D6-F88E-5E32-A26D91EEFCB2}"/>
              </a:ext>
            </a:extLst>
          </p:cNvPr>
          <p:cNvGrpSpPr/>
          <p:nvPr/>
        </p:nvGrpSpPr>
        <p:grpSpPr>
          <a:xfrm>
            <a:off x="216227" y="6544739"/>
            <a:ext cx="12104989" cy="276999"/>
            <a:chOff x="216227" y="6544739"/>
            <a:chExt cx="12104989" cy="276999"/>
          </a:xfrm>
        </p:grpSpPr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7DD4A9A3-20E2-0EE3-8013-ED2DCF39A095}"/>
                </a:ext>
              </a:extLst>
            </p:cNvPr>
            <p:cNvSpPr txBox="1"/>
            <p:nvPr/>
          </p:nvSpPr>
          <p:spPr>
            <a:xfrm>
              <a:off x="216227" y="6544739"/>
              <a:ext cx="121049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We note that bands marked with        are not part of the figure. </a:t>
              </a:r>
            </a:p>
          </p:txBody>
        </p:sp>
        <p:grpSp>
          <p:nvGrpSpPr>
            <p:cNvPr id="43" name="Group 42">
              <a:extLst>
                <a:ext uri="{FF2B5EF4-FFF2-40B4-BE49-F238E27FC236}">
                  <a16:creationId xmlns:a16="http://schemas.microsoft.com/office/drawing/2014/main" id="{C149B331-3901-1511-B5C4-870F1B58FEF3}"/>
                </a:ext>
              </a:extLst>
            </p:cNvPr>
            <p:cNvGrpSpPr/>
            <p:nvPr/>
          </p:nvGrpSpPr>
          <p:grpSpPr>
            <a:xfrm>
              <a:off x="6377868" y="6604605"/>
              <a:ext cx="273049" cy="179325"/>
              <a:chOff x="2141481" y="4906885"/>
              <a:chExt cx="242944" cy="276999"/>
            </a:xfrm>
          </p:grpSpPr>
          <p:sp>
            <p:nvSpPr>
              <p:cNvPr id="44" name="Rectangle 43">
                <a:extLst>
                  <a:ext uri="{FF2B5EF4-FFF2-40B4-BE49-F238E27FC236}">
                    <a16:creationId xmlns:a16="http://schemas.microsoft.com/office/drawing/2014/main" id="{9CA771D0-B25B-C7F3-37C1-8A488C99C64F}"/>
                  </a:ext>
                </a:extLst>
              </p:cNvPr>
              <p:cNvSpPr/>
              <p:nvPr/>
            </p:nvSpPr>
            <p:spPr>
              <a:xfrm>
                <a:off x="2141481" y="4906885"/>
                <a:ext cx="242944" cy="276999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45" name="Straight Connector 44">
                <a:extLst>
                  <a:ext uri="{FF2B5EF4-FFF2-40B4-BE49-F238E27FC236}">
                    <a16:creationId xmlns:a16="http://schemas.microsoft.com/office/drawing/2014/main" id="{4B3E4563-FD7F-A3F8-AAEB-A290480709A1}"/>
                  </a:ext>
                </a:extLst>
              </p:cNvPr>
              <p:cNvCxnSpPr/>
              <p:nvPr/>
            </p:nvCxnSpPr>
            <p:spPr>
              <a:xfrm flipH="1">
                <a:off x="2141481" y="4906885"/>
                <a:ext cx="242944" cy="275576"/>
              </a:xfrm>
              <a:prstGeom prst="line">
                <a:avLst/>
              </a:prstGeom>
              <a:ln w="12700">
                <a:solidFill>
                  <a:srgbClr val="2F528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29916604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5AA8CF1-7B2C-510A-8BC1-180F3704180D}"/>
              </a:ext>
            </a:extLst>
          </p:cNvPr>
          <p:cNvSpPr txBox="1"/>
          <p:nvPr/>
        </p:nvSpPr>
        <p:spPr>
          <a:xfrm>
            <a:off x="5610931" y="0"/>
            <a:ext cx="970137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200" dirty="0">
                <a:latin typeface="Arial" panose="020B0604020202020204" pitchFamily="34" charset="0"/>
                <a:cs typeface="Arial" panose="020B0604020202020204" pitchFamily="34" charset="0"/>
              </a:rPr>
              <a:t>Fig 2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5F1A9E2-A0C9-7586-AA53-87F4EFABDE3F}"/>
              </a:ext>
            </a:extLst>
          </p:cNvPr>
          <p:cNvSpPr txBox="1"/>
          <p:nvPr/>
        </p:nvSpPr>
        <p:spPr>
          <a:xfrm>
            <a:off x="2148727" y="362405"/>
            <a:ext cx="209704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hemoluminescence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2DA7CDB-93BA-7DFB-792B-648E25EB644B}"/>
              </a:ext>
            </a:extLst>
          </p:cNvPr>
          <p:cNvSpPr txBox="1"/>
          <p:nvPr/>
        </p:nvSpPr>
        <p:spPr>
          <a:xfrm>
            <a:off x="6400665" y="356593"/>
            <a:ext cx="8226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B95B938-EBD4-F599-E0F7-376C61EF76DD}"/>
              </a:ext>
            </a:extLst>
          </p:cNvPr>
          <p:cNvSpPr txBox="1"/>
          <p:nvPr/>
        </p:nvSpPr>
        <p:spPr>
          <a:xfrm>
            <a:off x="9968205" y="356592"/>
            <a:ext cx="8803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Merged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92BF7F9-9BB6-4E87-5A3D-D55074446A84}"/>
              </a:ext>
            </a:extLst>
          </p:cNvPr>
          <p:cNvSpPr txBox="1"/>
          <p:nvPr/>
        </p:nvSpPr>
        <p:spPr>
          <a:xfrm>
            <a:off x="359253" y="952201"/>
            <a:ext cx="10951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H3K9me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044D5D5-C620-1C71-E228-926B2C6AA1FD}"/>
              </a:ext>
            </a:extLst>
          </p:cNvPr>
          <p:cNvSpPr txBox="1"/>
          <p:nvPr/>
        </p:nvSpPr>
        <p:spPr>
          <a:xfrm>
            <a:off x="245441" y="1882936"/>
            <a:ext cx="12089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H3K27me3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100C66D-DAC8-6D84-643B-E7FF97829984}"/>
              </a:ext>
            </a:extLst>
          </p:cNvPr>
          <p:cNvSpPr txBox="1"/>
          <p:nvPr/>
        </p:nvSpPr>
        <p:spPr>
          <a:xfrm>
            <a:off x="518271" y="2712978"/>
            <a:ext cx="9361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Total H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45911C8-AB97-8405-F6DD-B28CADBDA09C}"/>
              </a:ext>
            </a:extLst>
          </p:cNvPr>
          <p:cNvSpPr txBox="1"/>
          <p:nvPr/>
        </p:nvSpPr>
        <p:spPr>
          <a:xfrm rot="16200000">
            <a:off x="-403262" y="1787992"/>
            <a:ext cx="1159820" cy="4924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600" b="1" dirty="0">
                <a:latin typeface="Arial" panose="020B0604020202020204" pitchFamily="34" charset="0"/>
                <a:cs typeface="Arial" panose="020B0604020202020204" pitchFamily="34" charset="0"/>
              </a:rPr>
              <a:t>Brain</a:t>
            </a:r>
            <a:endParaRPr lang="en-US" sz="2600" b="1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F3AD2EF-D24F-808E-D307-062881DF7172}"/>
              </a:ext>
            </a:extLst>
          </p:cNvPr>
          <p:cNvSpPr txBox="1"/>
          <p:nvPr/>
        </p:nvSpPr>
        <p:spPr>
          <a:xfrm rot="16200000">
            <a:off x="-491066" y="4861777"/>
            <a:ext cx="1365891" cy="4924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600" b="1" dirty="0">
                <a:latin typeface="Arial" panose="020B0604020202020204" pitchFamily="34" charset="0"/>
                <a:cs typeface="Arial" panose="020B0604020202020204" pitchFamily="34" charset="0"/>
              </a:rPr>
              <a:t>Muscle</a:t>
            </a:r>
            <a:endParaRPr lang="en-US" sz="2600" b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614FC63-97EF-9563-024A-01797B6083BD}"/>
              </a:ext>
            </a:extLst>
          </p:cNvPr>
          <p:cNvSpPr txBox="1"/>
          <p:nvPr/>
        </p:nvSpPr>
        <p:spPr>
          <a:xfrm>
            <a:off x="359253" y="3965605"/>
            <a:ext cx="10951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H3K9me3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E772CE2-9B9E-1BDE-761E-7EBEE893BFE7}"/>
              </a:ext>
            </a:extLst>
          </p:cNvPr>
          <p:cNvSpPr txBox="1"/>
          <p:nvPr/>
        </p:nvSpPr>
        <p:spPr>
          <a:xfrm>
            <a:off x="245441" y="4960488"/>
            <a:ext cx="12089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H3K27me3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0F1B085-27F0-8123-297E-13276C9C0D8A}"/>
              </a:ext>
            </a:extLst>
          </p:cNvPr>
          <p:cNvSpPr txBox="1"/>
          <p:nvPr/>
        </p:nvSpPr>
        <p:spPr>
          <a:xfrm>
            <a:off x="518271" y="5912272"/>
            <a:ext cx="9361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Total H3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2F7DBBEC-3220-3E4C-FE68-B081BAEDFC0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38403" y="658142"/>
            <a:ext cx="3517697" cy="926672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FD266261-A5C9-11F5-57F8-9FA0AC7AA1F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65341" y="670335"/>
            <a:ext cx="3493311" cy="902286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E87429C7-0A7E-DD4F-0B9A-A42E9AD0833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661734" y="670335"/>
            <a:ext cx="3493311" cy="902286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A07AF353-A02A-1838-ACE2-850CD713764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99961" y="1668132"/>
            <a:ext cx="3194581" cy="768163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B4AF275B-5F6B-591B-BFC1-1E00797F7D5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226899" y="1640698"/>
            <a:ext cx="3170195" cy="823031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A44A88E0-FB75-C4F2-574C-64DF7267EED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823292" y="1680325"/>
            <a:ext cx="3170195" cy="743776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090A66FA-9D8F-ADF6-0F95-4158B042A8E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438403" y="2501222"/>
            <a:ext cx="3517697" cy="762066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6BB40D63-C488-3410-AEAD-5C51BBA7FFA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065341" y="2473788"/>
            <a:ext cx="3493311" cy="816935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2F4195CD-0005-5EF4-CAB7-EB526B04063D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661734" y="2513415"/>
            <a:ext cx="3493311" cy="737680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99D85795-3E8E-1C70-0536-31CE385E53F2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581671" y="3683739"/>
            <a:ext cx="3231160" cy="902286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C59B52A7-93EF-5BBA-41FA-71A4C204B218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101920" y="3671546"/>
            <a:ext cx="3420152" cy="926672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026727E3-06F7-DB0E-6B76-69313EB1905D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8808051" y="3695932"/>
            <a:ext cx="3200677" cy="877900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E8D59FAB-EC21-EEC7-A26A-A76F6829EE17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636540" y="4678622"/>
            <a:ext cx="3121423" cy="902286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EFFD407A-373E-B0DB-9DAC-DA516714423B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5263478" y="4690815"/>
            <a:ext cx="3097036" cy="877900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AA4F7A3F-1F7B-E4C4-BF09-564DB93324F4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8856823" y="4690815"/>
            <a:ext cx="3103133" cy="877900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6F49BD46-ADF9-E0F4-C5E2-6D4898893C51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599961" y="5673082"/>
            <a:ext cx="3194581" cy="816935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664E8C81-ACB8-DC4B-1B4A-B2858E50F143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5223851" y="5666985"/>
            <a:ext cx="3176291" cy="829128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23FD8C09-D07D-8494-8670-988DE766120E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8820244" y="5688323"/>
            <a:ext cx="3176291" cy="786452"/>
          </a:xfrm>
          <a:prstGeom prst="rect">
            <a:avLst/>
          </a:prstGeom>
        </p:spPr>
      </p:pic>
      <p:grpSp>
        <p:nvGrpSpPr>
          <p:cNvPr id="47" name="Group 46">
            <a:extLst>
              <a:ext uri="{FF2B5EF4-FFF2-40B4-BE49-F238E27FC236}">
                <a16:creationId xmlns:a16="http://schemas.microsoft.com/office/drawing/2014/main" id="{B5DE74E5-EF73-58AC-26E8-7AB868744ED6}"/>
              </a:ext>
            </a:extLst>
          </p:cNvPr>
          <p:cNvGrpSpPr/>
          <p:nvPr/>
        </p:nvGrpSpPr>
        <p:grpSpPr>
          <a:xfrm>
            <a:off x="216227" y="6544739"/>
            <a:ext cx="12104989" cy="276999"/>
            <a:chOff x="216227" y="6544739"/>
            <a:chExt cx="12104989" cy="276999"/>
          </a:xfrm>
        </p:grpSpPr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F0760478-D39C-207E-24AE-FDAED8A36834}"/>
                </a:ext>
              </a:extLst>
            </p:cNvPr>
            <p:cNvSpPr txBox="1"/>
            <p:nvPr/>
          </p:nvSpPr>
          <p:spPr>
            <a:xfrm>
              <a:off x="216227" y="6544739"/>
              <a:ext cx="121049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We note that bands marked with        are not part of the figure. </a:t>
              </a:r>
            </a:p>
          </p:txBody>
        </p:sp>
        <p:grpSp>
          <p:nvGrpSpPr>
            <p:cNvPr id="49" name="Group 48">
              <a:extLst>
                <a:ext uri="{FF2B5EF4-FFF2-40B4-BE49-F238E27FC236}">
                  <a16:creationId xmlns:a16="http://schemas.microsoft.com/office/drawing/2014/main" id="{97E47BF0-971C-89C3-A1A8-54CF374BA063}"/>
                </a:ext>
              </a:extLst>
            </p:cNvPr>
            <p:cNvGrpSpPr/>
            <p:nvPr/>
          </p:nvGrpSpPr>
          <p:grpSpPr>
            <a:xfrm>
              <a:off x="6377868" y="6604605"/>
              <a:ext cx="273049" cy="179325"/>
              <a:chOff x="2141481" y="4906885"/>
              <a:chExt cx="242944" cy="276999"/>
            </a:xfrm>
          </p:grpSpPr>
          <p:sp>
            <p:nvSpPr>
              <p:cNvPr id="50" name="Rectangle 49">
                <a:extLst>
                  <a:ext uri="{FF2B5EF4-FFF2-40B4-BE49-F238E27FC236}">
                    <a16:creationId xmlns:a16="http://schemas.microsoft.com/office/drawing/2014/main" id="{8580477A-9E0D-BDD1-819B-71273DA6037F}"/>
                  </a:ext>
                </a:extLst>
              </p:cNvPr>
              <p:cNvSpPr/>
              <p:nvPr/>
            </p:nvSpPr>
            <p:spPr>
              <a:xfrm>
                <a:off x="2141481" y="4906885"/>
                <a:ext cx="242944" cy="276999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51" name="Straight Connector 50">
                <a:extLst>
                  <a:ext uri="{FF2B5EF4-FFF2-40B4-BE49-F238E27FC236}">
                    <a16:creationId xmlns:a16="http://schemas.microsoft.com/office/drawing/2014/main" id="{A829516D-B1A0-F954-D44C-7F5EC100F2A5}"/>
                  </a:ext>
                </a:extLst>
              </p:cNvPr>
              <p:cNvCxnSpPr/>
              <p:nvPr/>
            </p:nvCxnSpPr>
            <p:spPr>
              <a:xfrm flipH="1">
                <a:off x="2141481" y="4906885"/>
                <a:ext cx="242944" cy="275576"/>
              </a:xfrm>
              <a:prstGeom prst="line">
                <a:avLst/>
              </a:prstGeom>
              <a:ln w="12700">
                <a:solidFill>
                  <a:srgbClr val="2F528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19362632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1B7B4E0-FC8C-A316-F417-76C6AF681804}"/>
              </a:ext>
            </a:extLst>
          </p:cNvPr>
          <p:cNvSpPr txBox="1"/>
          <p:nvPr/>
        </p:nvSpPr>
        <p:spPr>
          <a:xfrm>
            <a:off x="5610931" y="0"/>
            <a:ext cx="970137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200" dirty="0">
                <a:latin typeface="Arial" panose="020B0604020202020204" pitchFamily="34" charset="0"/>
                <a:cs typeface="Arial" panose="020B0604020202020204" pitchFamily="34" charset="0"/>
              </a:rPr>
              <a:t>Fig 2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76E27E5-724A-565B-28A9-6BE1035EB4BA}"/>
              </a:ext>
            </a:extLst>
          </p:cNvPr>
          <p:cNvSpPr txBox="1"/>
          <p:nvPr/>
        </p:nvSpPr>
        <p:spPr>
          <a:xfrm>
            <a:off x="2059101" y="320699"/>
            <a:ext cx="209704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hemoluminescence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1E582CB-A70D-C964-53B3-CBF6E6F3795D}"/>
              </a:ext>
            </a:extLst>
          </p:cNvPr>
          <p:cNvSpPr txBox="1"/>
          <p:nvPr/>
        </p:nvSpPr>
        <p:spPr>
          <a:xfrm>
            <a:off x="6345410" y="314887"/>
            <a:ext cx="8226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59C424C-0064-4366-FF72-B61CA16D0E4B}"/>
              </a:ext>
            </a:extLst>
          </p:cNvPr>
          <p:cNvSpPr txBox="1"/>
          <p:nvPr/>
        </p:nvSpPr>
        <p:spPr>
          <a:xfrm>
            <a:off x="9800581" y="314886"/>
            <a:ext cx="8803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Merged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B480789-B170-53A1-0C73-0124F003EF22}"/>
              </a:ext>
            </a:extLst>
          </p:cNvPr>
          <p:cNvSpPr txBox="1"/>
          <p:nvPr/>
        </p:nvSpPr>
        <p:spPr>
          <a:xfrm>
            <a:off x="515774" y="903817"/>
            <a:ext cx="10951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H3K9me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66E6A06-D719-15C7-C2E7-845D0831764B}"/>
              </a:ext>
            </a:extLst>
          </p:cNvPr>
          <p:cNvSpPr txBox="1"/>
          <p:nvPr/>
        </p:nvSpPr>
        <p:spPr>
          <a:xfrm>
            <a:off x="401962" y="1786297"/>
            <a:ext cx="12089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H3K27me3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B1F8ACD-1AC4-5AFB-9954-0D6B06107878}"/>
              </a:ext>
            </a:extLst>
          </p:cNvPr>
          <p:cNvSpPr txBox="1"/>
          <p:nvPr/>
        </p:nvSpPr>
        <p:spPr>
          <a:xfrm>
            <a:off x="674792" y="2692329"/>
            <a:ext cx="9361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Total H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E3DC8B9-6B47-8905-1C61-0F03E7370273}"/>
              </a:ext>
            </a:extLst>
          </p:cNvPr>
          <p:cNvSpPr txBox="1"/>
          <p:nvPr/>
        </p:nvSpPr>
        <p:spPr>
          <a:xfrm rot="16200000">
            <a:off x="-391801" y="1735169"/>
            <a:ext cx="1159820" cy="4924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600" b="1" dirty="0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endParaRPr lang="en-US" sz="2600" b="1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A29C33F-E073-8E65-1E03-64CF4E32CB6B}"/>
              </a:ext>
            </a:extLst>
          </p:cNvPr>
          <p:cNvSpPr txBox="1"/>
          <p:nvPr/>
        </p:nvSpPr>
        <p:spPr>
          <a:xfrm rot="16200000">
            <a:off x="-491066" y="4877737"/>
            <a:ext cx="1365891" cy="4924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600" b="1" dirty="0">
                <a:latin typeface="Arial" panose="020B0604020202020204" pitchFamily="34" charset="0"/>
                <a:cs typeface="Arial" panose="020B0604020202020204" pitchFamily="34" charset="0"/>
              </a:rPr>
              <a:t>Heart</a:t>
            </a:r>
            <a:endParaRPr lang="en-US" sz="2600" b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2BD915E-98B4-6593-E39A-131FD1A04749}"/>
              </a:ext>
            </a:extLst>
          </p:cNvPr>
          <p:cNvSpPr txBox="1"/>
          <p:nvPr/>
        </p:nvSpPr>
        <p:spPr>
          <a:xfrm>
            <a:off x="515774" y="3977380"/>
            <a:ext cx="10951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H3K9me3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6F76A8A-34F5-A511-2645-680355E4830E}"/>
              </a:ext>
            </a:extLst>
          </p:cNvPr>
          <p:cNvSpPr txBox="1"/>
          <p:nvPr/>
        </p:nvSpPr>
        <p:spPr>
          <a:xfrm>
            <a:off x="401962" y="4900705"/>
            <a:ext cx="12089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H3K27me3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293762C-6CD8-51A6-5019-B1FA27FA877F}"/>
              </a:ext>
            </a:extLst>
          </p:cNvPr>
          <p:cNvSpPr txBox="1"/>
          <p:nvPr/>
        </p:nvSpPr>
        <p:spPr>
          <a:xfrm>
            <a:off x="674792" y="5833389"/>
            <a:ext cx="9361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Total H3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CACE3A00-4CE4-F399-9433-7A913F18429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33437" y="664627"/>
            <a:ext cx="3084843" cy="816935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CC768681-B2BB-B049-3A2C-D79F5DF30BD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35892" y="1547107"/>
            <a:ext cx="3279932" cy="816935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2305FB39-13B0-EBCE-52DA-C9C738DAFB7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29796" y="2434849"/>
            <a:ext cx="3292125" cy="853514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76D82CCE-64D1-4FD7-08F2-F4C75D8A9D1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26512" y="658530"/>
            <a:ext cx="3060457" cy="829128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86EB68DC-4DBD-14A6-CCFD-53B39FE6177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128967" y="1547107"/>
            <a:ext cx="3255546" cy="816935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27AC1949-5093-8DF4-8D42-DF988B99946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122871" y="2440946"/>
            <a:ext cx="3267739" cy="841321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21705FDF-513D-BF9A-8ADB-0B4F5F4A3A8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670719" y="676820"/>
            <a:ext cx="3066554" cy="792549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B10DFA8A-F3CB-F996-F150-9BF95B11B29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579271" y="1556252"/>
            <a:ext cx="3249450" cy="798645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62D3BBB2-7E44-46F4-908B-AF64FCD00304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570127" y="2447042"/>
            <a:ext cx="3267739" cy="829128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12BC3557-D06D-42D3-67C3-C0C64E9A811C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873657" y="3741238"/>
            <a:ext cx="2804403" cy="810838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8C2ED98D-B905-3860-C017-17F15B6B523B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366732" y="3698562"/>
            <a:ext cx="2780017" cy="896190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DA317E12-AD56-77E0-72EA-F35BC4532F04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8813988" y="3753431"/>
            <a:ext cx="2780017" cy="786452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7D748603-0B54-CD38-1A80-775B6386F027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745630" y="4646274"/>
            <a:ext cx="3060457" cy="847417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CBF9353D-79C6-7340-F69A-57A2038DDC1A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5235656" y="4603598"/>
            <a:ext cx="3042168" cy="932769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DDAAB47F-EB74-0AB3-521F-C0116D7DD4DB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8682912" y="4655418"/>
            <a:ext cx="3042168" cy="829128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D8239B27-7D4B-3735-C6D7-2E06BF2AAF93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660278" y="5597247"/>
            <a:ext cx="3231160" cy="810838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88AD2C21-61B8-E467-1689-4FE515A3C144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5153353" y="5578958"/>
            <a:ext cx="3206774" cy="847417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8AEA027C-2C4C-838B-5257-3E139811B9FF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8597561" y="5609440"/>
            <a:ext cx="3212870" cy="786452"/>
          </a:xfrm>
          <a:prstGeom prst="rect">
            <a:avLst/>
          </a:prstGeom>
        </p:spPr>
      </p:pic>
      <p:grpSp>
        <p:nvGrpSpPr>
          <p:cNvPr id="2" name="Group 1">
            <a:extLst>
              <a:ext uri="{FF2B5EF4-FFF2-40B4-BE49-F238E27FC236}">
                <a16:creationId xmlns:a16="http://schemas.microsoft.com/office/drawing/2014/main" id="{089245AF-03D3-F504-D962-5FB1D0EE9FBE}"/>
              </a:ext>
            </a:extLst>
          </p:cNvPr>
          <p:cNvGrpSpPr/>
          <p:nvPr/>
        </p:nvGrpSpPr>
        <p:grpSpPr>
          <a:xfrm>
            <a:off x="216227" y="6544739"/>
            <a:ext cx="12104989" cy="276999"/>
            <a:chOff x="216227" y="6544739"/>
            <a:chExt cx="12104989" cy="276999"/>
          </a:xfrm>
        </p:grpSpPr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738BB6FC-6CD3-561B-CD03-48D28A818FC9}"/>
                </a:ext>
              </a:extLst>
            </p:cNvPr>
            <p:cNvSpPr txBox="1"/>
            <p:nvPr/>
          </p:nvSpPr>
          <p:spPr>
            <a:xfrm>
              <a:off x="216227" y="6544739"/>
              <a:ext cx="121049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We note that bands marked with        are not part of the figure. </a:t>
              </a:r>
            </a:p>
          </p:txBody>
        </p:sp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E984C4F1-544E-B5E2-1FC3-D3ACCC697217}"/>
                </a:ext>
              </a:extLst>
            </p:cNvPr>
            <p:cNvGrpSpPr/>
            <p:nvPr/>
          </p:nvGrpSpPr>
          <p:grpSpPr>
            <a:xfrm>
              <a:off x="6377868" y="6604605"/>
              <a:ext cx="273049" cy="179325"/>
              <a:chOff x="2141481" y="4906885"/>
              <a:chExt cx="242944" cy="276999"/>
            </a:xfrm>
          </p:grpSpPr>
          <p:sp>
            <p:nvSpPr>
              <p:cNvPr id="37" name="Rectangle 36">
                <a:extLst>
                  <a:ext uri="{FF2B5EF4-FFF2-40B4-BE49-F238E27FC236}">
                    <a16:creationId xmlns:a16="http://schemas.microsoft.com/office/drawing/2014/main" id="{E27F65E2-BD1B-ECFC-3DB0-0DA53A0B3A97}"/>
                  </a:ext>
                </a:extLst>
              </p:cNvPr>
              <p:cNvSpPr/>
              <p:nvPr/>
            </p:nvSpPr>
            <p:spPr>
              <a:xfrm>
                <a:off x="2141481" y="4906885"/>
                <a:ext cx="242944" cy="276999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38" name="Straight Connector 37">
                <a:extLst>
                  <a:ext uri="{FF2B5EF4-FFF2-40B4-BE49-F238E27FC236}">
                    <a16:creationId xmlns:a16="http://schemas.microsoft.com/office/drawing/2014/main" id="{56D832F3-04E4-6BC9-FE91-08DF081204AF}"/>
                  </a:ext>
                </a:extLst>
              </p:cNvPr>
              <p:cNvCxnSpPr/>
              <p:nvPr/>
            </p:nvCxnSpPr>
            <p:spPr>
              <a:xfrm flipH="1">
                <a:off x="2141481" y="4906885"/>
                <a:ext cx="242944" cy="275576"/>
              </a:xfrm>
              <a:prstGeom prst="line">
                <a:avLst/>
              </a:prstGeom>
              <a:ln w="12700">
                <a:solidFill>
                  <a:srgbClr val="2F528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12155202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60331CB-49E5-41B3-1B97-3F384143A933}"/>
              </a:ext>
            </a:extLst>
          </p:cNvPr>
          <p:cNvSpPr txBox="1"/>
          <p:nvPr/>
        </p:nvSpPr>
        <p:spPr>
          <a:xfrm>
            <a:off x="5282448" y="294423"/>
            <a:ext cx="1595309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600" dirty="0">
                <a:latin typeface="Arial" panose="020B0604020202020204" pitchFamily="34" charset="0"/>
                <a:cs typeface="Arial" panose="020B0604020202020204" pitchFamily="34" charset="0"/>
              </a:rPr>
              <a:t>Figure 4d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A48FC2F-A641-F36C-19DF-B0212BAE4CD7}"/>
              </a:ext>
            </a:extLst>
          </p:cNvPr>
          <p:cNvSpPr txBox="1"/>
          <p:nvPr/>
        </p:nvSpPr>
        <p:spPr>
          <a:xfrm>
            <a:off x="1450620" y="1904261"/>
            <a:ext cx="10951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H3K9me3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A084963-E379-0A35-4647-0AADA4D3C0A5}"/>
              </a:ext>
            </a:extLst>
          </p:cNvPr>
          <p:cNvSpPr txBox="1"/>
          <p:nvPr/>
        </p:nvSpPr>
        <p:spPr>
          <a:xfrm>
            <a:off x="1336808" y="2982979"/>
            <a:ext cx="12089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H3K27me3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505FC93-CE8F-F206-6F70-03C541B79AC2}"/>
              </a:ext>
            </a:extLst>
          </p:cNvPr>
          <p:cNvSpPr txBox="1"/>
          <p:nvPr/>
        </p:nvSpPr>
        <p:spPr>
          <a:xfrm>
            <a:off x="1609638" y="4076605"/>
            <a:ext cx="9361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Total H3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ECEFCF0-75D3-C12E-E754-915811509CF0}"/>
              </a:ext>
            </a:extLst>
          </p:cNvPr>
          <p:cNvSpPr txBox="1"/>
          <p:nvPr/>
        </p:nvSpPr>
        <p:spPr>
          <a:xfrm>
            <a:off x="2712226" y="1169997"/>
            <a:ext cx="209704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hemoluminescenc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DDAEFA4-BC1F-CB1D-1312-5F8A83F4664C}"/>
              </a:ext>
            </a:extLst>
          </p:cNvPr>
          <p:cNvSpPr txBox="1"/>
          <p:nvPr/>
        </p:nvSpPr>
        <p:spPr>
          <a:xfrm>
            <a:off x="5693789" y="1169997"/>
            <a:ext cx="8226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682CF93-8E93-5A7E-4428-1AEB6C45D3B6}"/>
              </a:ext>
            </a:extLst>
          </p:cNvPr>
          <p:cNvSpPr txBox="1"/>
          <p:nvPr/>
        </p:nvSpPr>
        <p:spPr>
          <a:xfrm>
            <a:off x="8017024" y="1169997"/>
            <a:ext cx="8803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Merged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0AB9B205-F97D-5FA5-AD8D-361C0BAC5BE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77939" y="1598009"/>
            <a:ext cx="1365622" cy="951058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BE72A22E-CAFD-18B8-3524-F3E27F5C035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63375" y="2676727"/>
            <a:ext cx="2194750" cy="951058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10C587B3-EC49-E5E4-DF25-EC4F8438A81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22478" y="3761208"/>
            <a:ext cx="1676545" cy="969348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23DE4C11-E3A2-A933-235D-2CF486BE838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419260" y="1610202"/>
            <a:ext cx="1371719" cy="926672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94613935-908D-9BCC-A32C-F780431978A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044323" y="2688920"/>
            <a:ext cx="2121592" cy="926672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490BBF40-B4DF-EE7B-AE85-3126AB12A26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279040" y="3773401"/>
            <a:ext cx="1652159" cy="944962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F9A48862-8267-84D5-DDD7-CBFA4AC99C7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771349" y="1610202"/>
            <a:ext cx="1371719" cy="926672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F227C5E5-4D25-58AC-1DA6-956A5327B66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393364" y="2688920"/>
            <a:ext cx="2127688" cy="926672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59AAF6EB-038D-37A5-132A-0E97DF7D9B85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631129" y="3773401"/>
            <a:ext cx="1652159" cy="9449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0752154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6A4BB35-D735-7364-0B30-B211B7D159EA}"/>
              </a:ext>
            </a:extLst>
          </p:cNvPr>
          <p:cNvSpPr txBox="1"/>
          <p:nvPr/>
        </p:nvSpPr>
        <p:spPr>
          <a:xfrm>
            <a:off x="2512224" y="508807"/>
            <a:ext cx="209704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hemoluminescence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8539DF9-AC7B-CEEF-C583-B3A9613EE2DE}"/>
              </a:ext>
            </a:extLst>
          </p:cNvPr>
          <p:cNvSpPr txBox="1"/>
          <p:nvPr/>
        </p:nvSpPr>
        <p:spPr>
          <a:xfrm>
            <a:off x="5734683" y="508807"/>
            <a:ext cx="8226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CF9DD23-215F-9FE5-0EBD-267ADE559F92}"/>
              </a:ext>
            </a:extLst>
          </p:cNvPr>
          <p:cNvSpPr txBox="1"/>
          <p:nvPr/>
        </p:nvSpPr>
        <p:spPr>
          <a:xfrm>
            <a:off x="8328376" y="508807"/>
            <a:ext cx="8803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Merged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2C93070-92BD-0E04-E1F2-E999E7881AFC}"/>
              </a:ext>
            </a:extLst>
          </p:cNvPr>
          <p:cNvSpPr txBox="1"/>
          <p:nvPr/>
        </p:nvSpPr>
        <p:spPr>
          <a:xfrm>
            <a:off x="5618679" y="66675"/>
            <a:ext cx="970137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200" dirty="0">
                <a:latin typeface="Arial" panose="020B0604020202020204" pitchFamily="34" charset="0"/>
                <a:cs typeface="Arial" panose="020B0604020202020204" pitchFamily="34" charset="0"/>
              </a:rPr>
              <a:t>Fig 6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164C890-06D2-E25C-5F08-A124C4F011BA}"/>
              </a:ext>
            </a:extLst>
          </p:cNvPr>
          <p:cNvSpPr txBox="1"/>
          <p:nvPr/>
        </p:nvSpPr>
        <p:spPr>
          <a:xfrm>
            <a:off x="5618679" y="3631125"/>
            <a:ext cx="970137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200" dirty="0">
                <a:latin typeface="Arial" panose="020B0604020202020204" pitchFamily="34" charset="0"/>
                <a:cs typeface="Arial" panose="020B0604020202020204" pitchFamily="34" charset="0"/>
              </a:rPr>
              <a:t>Fig 6d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8071EA3-4616-9596-5ABC-2522D855C80F}"/>
              </a:ext>
            </a:extLst>
          </p:cNvPr>
          <p:cNvSpPr txBox="1"/>
          <p:nvPr/>
        </p:nvSpPr>
        <p:spPr>
          <a:xfrm>
            <a:off x="245992" y="4526433"/>
            <a:ext cx="10951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H3K9me3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AAADD63-3ED7-BAF1-04A9-7EE41ACADFEE}"/>
              </a:ext>
            </a:extLst>
          </p:cNvPr>
          <p:cNvSpPr txBox="1"/>
          <p:nvPr/>
        </p:nvSpPr>
        <p:spPr>
          <a:xfrm>
            <a:off x="132180" y="5204067"/>
            <a:ext cx="12089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H3K27me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9226794-3A78-566C-C830-F24F71E67A57}"/>
              </a:ext>
            </a:extLst>
          </p:cNvPr>
          <p:cNvSpPr txBox="1"/>
          <p:nvPr/>
        </p:nvSpPr>
        <p:spPr>
          <a:xfrm>
            <a:off x="405010" y="5907912"/>
            <a:ext cx="9361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Total H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7C0C5A7-781D-D1D1-F9F2-DFD4C4AF782C}"/>
              </a:ext>
            </a:extLst>
          </p:cNvPr>
          <p:cNvSpPr txBox="1"/>
          <p:nvPr/>
        </p:nvSpPr>
        <p:spPr>
          <a:xfrm>
            <a:off x="1293356" y="1005971"/>
            <a:ext cx="10951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H3K9me3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32E354C-FF72-C779-3DB9-ED712D1D7A07}"/>
              </a:ext>
            </a:extLst>
          </p:cNvPr>
          <p:cNvSpPr txBox="1"/>
          <p:nvPr/>
        </p:nvSpPr>
        <p:spPr>
          <a:xfrm>
            <a:off x="1179544" y="1764673"/>
            <a:ext cx="12089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H3K27me3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A449AA6-7B57-6BB2-954D-B02C41BA0F4A}"/>
              </a:ext>
            </a:extLst>
          </p:cNvPr>
          <p:cNvSpPr txBox="1"/>
          <p:nvPr/>
        </p:nvSpPr>
        <p:spPr>
          <a:xfrm>
            <a:off x="1452374" y="2592973"/>
            <a:ext cx="9361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Total H3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B924B16B-87A2-059B-BD7B-4A17097A658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57277" y="833842"/>
            <a:ext cx="2206943" cy="682811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63F98A6D-A168-CC51-72B7-22A35F34943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87167" y="1592545"/>
            <a:ext cx="2347163" cy="682811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64EF8D48-AE16-CF7E-6D97-1149FA9603A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87167" y="2390362"/>
            <a:ext cx="2347163" cy="743776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1F113357-BACA-D5B5-9DBC-3EA9640A67E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054735" y="858608"/>
            <a:ext cx="2182557" cy="688908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66D6FAC5-CDC9-BF46-8044-6108FF2EBF7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984625" y="1589496"/>
            <a:ext cx="2322777" cy="688908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5DE928DF-40E5-AC98-7D27-A18091296D1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984625" y="2402555"/>
            <a:ext cx="2322777" cy="719390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ABE99DFA-5385-E0A1-0B56-375697B6E8B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677282" y="833842"/>
            <a:ext cx="2182557" cy="658425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9A280FBC-8B6F-DD48-7232-53440D5E477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607172" y="1604738"/>
            <a:ext cx="2322777" cy="658425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5967D011-42F6-EB58-13AD-C7B925C590B6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607172" y="2402555"/>
            <a:ext cx="2322777" cy="719390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E75D6545-89CC-CE7C-7D90-E74D948E758C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353822" y="4439656"/>
            <a:ext cx="2987299" cy="512108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AEBAD30F-AF81-7ADD-1523-C5FC670327F9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329436" y="5071566"/>
            <a:ext cx="3036071" cy="603556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38C171DC-6769-EDBF-EFAE-962D24084230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302001" y="5793701"/>
            <a:ext cx="3090940" cy="566977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1FB8EC3E-747E-220F-2095-C83228A01830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709932" y="4442704"/>
            <a:ext cx="2962913" cy="506012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88DE5AB2-E584-4F35-4602-3729BEEF354C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685546" y="5022794"/>
            <a:ext cx="3011685" cy="701101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E9E7DFA5-21EE-DA82-4D28-C57917FA9373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661160" y="5723591"/>
            <a:ext cx="3060457" cy="707197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8CEFA52F-D204-4731-4E15-F748506601EB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7969465" y="4451849"/>
            <a:ext cx="2962913" cy="487722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C4407AF5-2D82-D2BB-E5F0-5F292ADC05BD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7945079" y="5055184"/>
            <a:ext cx="3011685" cy="579170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96694695-8CF1-A304-835D-DD050470AB66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7920693" y="5777319"/>
            <a:ext cx="3060457" cy="542591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BE200479-B8C0-7A3D-B17A-837E3D4193A0}"/>
              </a:ext>
            </a:extLst>
          </p:cNvPr>
          <p:cNvSpPr txBox="1"/>
          <p:nvPr/>
        </p:nvSpPr>
        <p:spPr>
          <a:xfrm>
            <a:off x="1798947" y="4109828"/>
            <a:ext cx="209704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hemoluminescence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62163C51-B07E-D518-EC91-0A45B76C36B4}"/>
              </a:ext>
            </a:extLst>
          </p:cNvPr>
          <p:cNvSpPr txBox="1"/>
          <p:nvPr/>
        </p:nvSpPr>
        <p:spPr>
          <a:xfrm>
            <a:off x="5780058" y="4109828"/>
            <a:ext cx="8226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0F411D7D-99D4-9301-7AFF-31EFB6D42649}"/>
              </a:ext>
            </a:extLst>
          </p:cNvPr>
          <p:cNvSpPr txBox="1"/>
          <p:nvPr/>
        </p:nvSpPr>
        <p:spPr>
          <a:xfrm>
            <a:off x="9010737" y="4109828"/>
            <a:ext cx="8803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Merged</a:t>
            </a:r>
          </a:p>
        </p:txBody>
      </p:sp>
      <p:grpSp>
        <p:nvGrpSpPr>
          <p:cNvPr id="36" name="Group 35">
            <a:extLst>
              <a:ext uri="{FF2B5EF4-FFF2-40B4-BE49-F238E27FC236}">
                <a16:creationId xmlns:a16="http://schemas.microsoft.com/office/drawing/2014/main" id="{99318544-9E4B-EFB4-5FF6-A82BA7CD39BE}"/>
              </a:ext>
            </a:extLst>
          </p:cNvPr>
          <p:cNvGrpSpPr/>
          <p:nvPr/>
        </p:nvGrpSpPr>
        <p:grpSpPr>
          <a:xfrm>
            <a:off x="311477" y="6532090"/>
            <a:ext cx="12104989" cy="276999"/>
            <a:chOff x="311477" y="6474940"/>
            <a:chExt cx="12104989" cy="276999"/>
          </a:xfrm>
        </p:grpSpPr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0563C562-ADF6-3D46-05D7-993E7BDD1B2B}"/>
                </a:ext>
              </a:extLst>
            </p:cNvPr>
            <p:cNvSpPr txBox="1"/>
            <p:nvPr/>
          </p:nvSpPr>
          <p:spPr>
            <a:xfrm>
              <a:off x="311477" y="6474940"/>
              <a:ext cx="121049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We note that         marks picture shown in corresponding figure.   </a:t>
              </a:r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71E3DDB6-9F8F-4A17-33AA-3B6B6629A4FF}"/>
                </a:ext>
              </a:extLst>
            </p:cNvPr>
            <p:cNvSpPr/>
            <p:nvPr/>
          </p:nvSpPr>
          <p:spPr>
            <a:xfrm>
              <a:off x="5155130" y="6535895"/>
              <a:ext cx="273049" cy="17932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58920074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6A4BB35-D735-7364-0B30-B211B7D159EA}"/>
              </a:ext>
            </a:extLst>
          </p:cNvPr>
          <p:cNvSpPr txBox="1"/>
          <p:nvPr/>
        </p:nvSpPr>
        <p:spPr>
          <a:xfrm>
            <a:off x="3338994" y="466897"/>
            <a:ext cx="209704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hemoluminescence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8539DF9-AC7B-CEEF-C583-B3A9613EE2DE}"/>
              </a:ext>
            </a:extLst>
          </p:cNvPr>
          <p:cNvSpPr txBox="1"/>
          <p:nvPr/>
        </p:nvSpPr>
        <p:spPr>
          <a:xfrm>
            <a:off x="5738376" y="466897"/>
            <a:ext cx="8226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CF9DD23-215F-9FE5-0EBD-267ADE559F92}"/>
              </a:ext>
            </a:extLst>
          </p:cNvPr>
          <p:cNvSpPr txBox="1"/>
          <p:nvPr/>
        </p:nvSpPr>
        <p:spPr>
          <a:xfrm>
            <a:off x="7359680" y="466897"/>
            <a:ext cx="8803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Merged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2C93070-92BD-0E04-E1F2-E999E7881AFC}"/>
              </a:ext>
            </a:extLst>
          </p:cNvPr>
          <p:cNvSpPr txBox="1"/>
          <p:nvPr/>
        </p:nvSpPr>
        <p:spPr>
          <a:xfrm>
            <a:off x="5618679" y="66675"/>
            <a:ext cx="970138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200" dirty="0">
                <a:latin typeface="Arial" panose="020B0604020202020204" pitchFamily="34" charset="0"/>
                <a:cs typeface="Arial" panose="020B0604020202020204" pitchFamily="34" charset="0"/>
              </a:rPr>
              <a:t>Fig 8a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ADF53CE-241A-80A7-D895-6A92EF5F17C2}"/>
              </a:ext>
            </a:extLst>
          </p:cNvPr>
          <p:cNvSpPr txBox="1"/>
          <p:nvPr/>
        </p:nvSpPr>
        <p:spPr>
          <a:xfrm>
            <a:off x="2922668" y="1043715"/>
            <a:ext cx="6848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TET2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3AE5FE1F-CF78-8EE8-7C31-8A95D746E54E}"/>
              </a:ext>
            </a:extLst>
          </p:cNvPr>
          <p:cNvSpPr txBox="1"/>
          <p:nvPr/>
        </p:nvSpPr>
        <p:spPr>
          <a:xfrm>
            <a:off x="2695042" y="2134053"/>
            <a:ext cx="9124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2D7EDC04-0CF5-7BD6-8515-E4A0594E773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47383" y="801477"/>
            <a:ext cx="1280271" cy="823031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212CACAF-E0AF-2876-8480-9D79231DB59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18716" y="813670"/>
            <a:ext cx="1261981" cy="798645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17E81A6D-2564-A29C-58D1-BDCB8074492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171922" y="813670"/>
            <a:ext cx="1255885" cy="798645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33D196FA-AB25-E82B-8385-9E444868C19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47383" y="1766836"/>
            <a:ext cx="1280271" cy="1072989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D9C852DB-6C8E-97D7-58E2-7A20A69FE63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518716" y="1738639"/>
            <a:ext cx="1261981" cy="1091279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4596F020-95DE-7EE3-1E83-BA4FB5CE5CE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171922" y="1779029"/>
            <a:ext cx="1255885" cy="1048603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CA47EF3B-899B-42B1-52AF-91B10ACAC404}"/>
              </a:ext>
            </a:extLst>
          </p:cNvPr>
          <p:cNvSpPr txBox="1"/>
          <p:nvPr/>
        </p:nvSpPr>
        <p:spPr>
          <a:xfrm>
            <a:off x="5450858" y="3120839"/>
            <a:ext cx="1127232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200" dirty="0">
                <a:latin typeface="Arial" panose="020B0604020202020204" pitchFamily="34" charset="0"/>
                <a:cs typeface="Arial" panose="020B0604020202020204" pitchFamily="34" charset="0"/>
              </a:rPr>
              <a:t>Fig 10b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505CC845-5FF9-4EAC-DD99-FA5D29B88FFC}"/>
              </a:ext>
            </a:extLst>
          </p:cNvPr>
          <p:cNvSpPr txBox="1"/>
          <p:nvPr/>
        </p:nvSpPr>
        <p:spPr>
          <a:xfrm>
            <a:off x="1633811" y="3583962"/>
            <a:ext cx="209704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hemoluminescence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81001967-2162-CCB6-B30D-189986FDFD06}"/>
              </a:ext>
            </a:extLst>
          </p:cNvPr>
          <p:cNvSpPr txBox="1"/>
          <p:nvPr/>
        </p:nvSpPr>
        <p:spPr>
          <a:xfrm>
            <a:off x="5809419" y="3583962"/>
            <a:ext cx="8226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1A8626A2-5232-A82C-8FA6-2294E45FF8C6}"/>
              </a:ext>
            </a:extLst>
          </p:cNvPr>
          <p:cNvSpPr txBox="1"/>
          <p:nvPr/>
        </p:nvSpPr>
        <p:spPr>
          <a:xfrm>
            <a:off x="9351516" y="3583962"/>
            <a:ext cx="8803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Merged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DE56211D-468F-9D46-B109-2230623B8924}"/>
              </a:ext>
            </a:extLst>
          </p:cNvPr>
          <p:cNvSpPr txBox="1"/>
          <p:nvPr/>
        </p:nvSpPr>
        <p:spPr>
          <a:xfrm>
            <a:off x="291332" y="4109895"/>
            <a:ext cx="6848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TET1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E021812C-7E9B-191F-1307-871B3FD6D038}"/>
              </a:ext>
            </a:extLst>
          </p:cNvPr>
          <p:cNvSpPr txBox="1"/>
          <p:nvPr/>
        </p:nvSpPr>
        <p:spPr>
          <a:xfrm>
            <a:off x="291332" y="4906631"/>
            <a:ext cx="6848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TET2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24D54E07-A348-65C0-DDF9-23C99C8ADBD2}"/>
              </a:ext>
            </a:extLst>
          </p:cNvPr>
          <p:cNvSpPr txBox="1"/>
          <p:nvPr/>
        </p:nvSpPr>
        <p:spPr>
          <a:xfrm>
            <a:off x="63706" y="5754362"/>
            <a:ext cx="9124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pic>
        <p:nvPicPr>
          <p:cNvPr id="49" name="Picture 48">
            <a:extLst>
              <a:ext uri="{FF2B5EF4-FFF2-40B4-BE49-F238E27FC236}">
                <a16:creationId xmlns:a16="http://schemas.microsoft.com/office/drawing/2014/main" id="{0C43FA17-38A7-5A50-7DB3-E7FF699BC7C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895883" y="3928622"/>
            <a:ext cx="1572904" cy="701101"/>
          </a:xfrm>
          <a:prstGeom prst="rect">
            <a:avLst/>
          </a:prstGeom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E4B5A95C-42E8-2EED-621F-81BC7C58C2A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449538" y="3925574"/>
            <a:ext cx="1542422" cy="707197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A63B0BB7-E51F-7264-6DCE-254745898649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9020489" y="3940815"/>
            <a:ext cx="1542422" cy="676715"/>
          </a:xfrm>
          <a:prstGeom prst="rect">
            <a:avLst/>
          </a:prstGeom>
        </p:spPr>
      </p:pic>
      <p:pic>
        <p:nvPicPr>
          <p:cNvPr id="52" name="Picture 51">
            <a:extLst>
              <a:ext uri="{FF2B5EF4-FFF2-40B4-BE49-F238E27FC236}">
                <a16:creationId xmlns:a16="http://schemas.microsoft.com/office/drawing/2014/main" id="{98F7172C-18FD-EA28-23A8-9A4BB17D6313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798339" y="4719261"/>
            <a:ext cx="1767993" cy="713294"/>
          </a:xfrm>
          <a:prstGeom prst="rect">
            <a:avLst/>
          </a:prstGeom>
        </p:spPr>
      </p:pic>
      <p:pic>
        <p:nvPicPr>
          <p:cNvPr id="53" name="Picture 52">
            <a:extLst>
              <a:ext uri="{FF2B5EF4-FFF2-40B4-BE49-F238E27FC236}">
                <a16:creationId xmlns:a16="http://schemas.microsoft.com/office/drawing/2014/main" id="{A33F8815-9D80-16DE-FE3C-D52DAA4CF91E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348946" y="4725358"/>
            <a:ext cx="1743607" cy="701101"/>
          </a:xfrm>
          <a:prstGeom prst="rect">
            <a:avLst/>
          </a:prstGeom>
        </p:spPr>
      </p:pic>
      <p:pic>
        <p:nvPicPr>
          <p:cNvPr id="54" name="Picture 53">
            <a:extLst>
              <a:ext uri="{FF2B5EF4-FFF2-40B4-BE49-F238E27FC236}">
                <a16:creationId xmlns:a16="http://schemas.microsoft.com/office/drawing/2014/main" id="{4B85E336-D19E-A1DB-C27C-1434565DC047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8919897" y="4731454"/>
            <a:ext cx="1743607" cy="688908"/>
          </a:xfrm>
          <a:prstGeom prst="rect">
            <a:avLst/>
          </a:prstGeom>
        </p:spPr>
      </p:pic>
      <p:pic>
        <p:nvPicPr>
          <p:cNvPr id="55" name="Picture 54">
            <a:extLst>
              <a:ext uri="{FF2B5EF4-FFF2-40B4-BE49-F238E27FC236}">
                <a16:creationId xmlns:a16="http://schemas.microsoft.com/office/drawing/2014/main" id="{96FD4A4A-9521-2758-45F6-2F6D34AC4E52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960066" y="5511357"/>
            <a:ext cx="3444539" cy="938865"/>
          </a:xfrm>
          <a:prstGeom prst="rect">
            <a:avLst/>
          </a:prstGeom>
        </p:spPr>
      </p:pic>
      <p:pic>
        <p:nvPicPr>
          <p:cNvPr id="56" name="Picture 55">
            <a:extLst>
              <a:ext uri="{FF2B5EF4-FFF2-40B4-BE49-F238E27FC236}">
                <a16:creationId xmlns:a16="http://schemas.microsoft.com/office/drawing/2014/main" id="{B6A7B4E3-470A-68BC-4978-E70213CE3354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510673" y="5521268"/>
            <a:ext cx="3420152" cy="804742"/>
          </a:xfrm>
          <a:prstGeom prst="rect">
            <a:avLst/>
          </a:prstGeom>
        </p:spPr>
      </p:pic>
      <p:pic>
        <p:nvPicPr>
          <p:cNvPr id="57" name="Picture 56">
            <a:extLst>
              <a:ext uri="{FF2B5EF4-FFF2-40B4-BE49-F238E27FC236}">
                <a16:creationId xmlns:a16="http://schemas.microsoft.com/office/drawing/2014/main" id="{82C9A0EC-BEE0-A241-C571-1670FA99DA4F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8081624" y="5521268"/>
            <a:ext cx="3420152" cy="804742"/>
          </a:xfrm>
          <a:prstGeom prst="rect">
            <a:avLst/>
          </a:prstGeom>
        </p:spPr>
      </p:pic>
      <p:grpSp>
        <p:nvGrpSpPr>
          <p:cNvPr id="58" name="Group 57">
            <a:extLst>
              <a:ext uri="{FF2B5EF4-FFF2-40B4-BE49-F238E27FC236}">
                <a16:creationId xmlns:a16="http://schemas.microsoft.com/office/drawing/2014/main" id="{2B5AE843-7B45-31F5-A8B7-5CFC16D0CB80}"/>
              </a:ext>
            </a:extLst>
          </p:cNvPr>
          <p:cNvGrpSpPr/>
          <p:nvPr/>
        </p:nvGrpSpPr>
        <p:grpSpPr>
          <a:xfrm>
            <a:off x="311477" y="6503515"/>
            <a:ext cx="12104989" cy="276999"/>
            <a:chOff x="311477" y="6474940"/>
            <a:chExt cx="12104989" cy="276999"/>
          </a:xfrm>
        </p:grpSpPr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C1A51E13-F0EE-B717-D5F9-65EF6006F134}"/>
                </a:ext>
              </a:extLst>
            </p:cNvPr>
            <p:cNvSpPr txBox="1"/>
            <p:nvPr/>
          </p:nvSpPr>
          <p:spPr>
            <a:xfrm>
              <a:off x="311477" y="6474940"/>
              <a:ext cx="121049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We note that         marks picture shown in corresponding figure.   </a:t>
              </a:r>
            </a:p>
          </p:txBody>
        </p:sp>
        <p:sp>
          <p:nvSpPr>
            <p:cNvPr id="60" name="Rectangle 59">
              <a:extLst>
                <a:ext uri="{FF2B5EF4-FFF2-40B4-BE49-F238E27FC236}">
                  <a16:creationId xmlns:a16="http://schemas.microsoft.com/office/drawing/2014/main" id="{605A3B96-1C00-DBE2-3432-28DE6DE38555}"/>
                </a:ext>
              </a:extLst>
            </p:cNvPr>
            <p:cNvSpPr/>
            <p:nvPr/>
          </p:nvSpPr>
          <p:spPr>
            <a:xfrm>
              <a:off x="5155130" y="6535895"/>
              <a:ext cx="273049" cy="17932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32064053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2</TotalTime>
  <Words>146</Words>
  <Application>Microsoft Office PowerPoint</Application>
  <PresentationFormat>Widescreen</PresentationFormat>
  <Paragraphs>75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ayo Clini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aler, Roman, Ph.D.</dc:creator>
  <cp:lastModifiedBy>Thaler, Roman, Ph.D.</cp:lastModifiedBy>
  <cp:revision>20</cp:revision>
  <dcterms:created xsi:type="dcterms:W3CDTF">2022-06-30T14:50:29Z</dcterms:created>
  <dcterms:modified xsi:type="dcterms:W3CDTF">2022-07-07T00:15:00Z</dcterms:modified>
</cp:coreProperties>
</file>